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9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332DEA-F77B-A4A7-BB81-39053A1ED7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84458D-2B00-AB2A-47EA-543C4D614F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33790A-D9B7-6DB4-CBDB-BC2C6201B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780256-4F56-2EC4-5715-74D8185DE6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97D347-AA28-CB2B-5D66-F47C2256D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805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1D4524-F043-B0FD-4875-0AF35BE2D0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481C96-12E0-397D-F998-12C93B8DA3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F0FD30-ACCB-ADE0-656A-2EC882ACB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62DE95-7E50-F5E9-1743-D1D49578C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42B69E-7BCF-6953-11E7-C7EB55B44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250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ED72E9-1B7B-AEB7-BCCB-4F1B7956F1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EB1259-E8E4-A6AE-3EA8-CBE0FB97E1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3914C7-8DD8-D5E4-E477-7BE2B12FA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FACBC0-AE71-4244-65D0-E96900384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A7ED01-800B-432D-B50C-BBC8DEE28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798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33649E-5373-27EC-C554-EE9580D84E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BE70AE-0A5B-44BE-0BA5-4D78590238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07CD98-9549-D8AF-0D88-C5CD617C0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8EBEA3-1850-D55B-6A0B-C9743F213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0FC427-8A0F-7E23-F0D1-5255968D97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224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DE013-4277-5AEA-B893-A8C32B47A0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2AC3ED-5A8A-AA11-B8D7-DFCC4B17D4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655C1D-468A-BA24-42A9-606E05B07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41669D-B6A8-490E-88B0-EBE0E2573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63E411-B237-7C61-3712-EC9A5C5F7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873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D7A2C4-C9F5-EF7B-48E8-B768299A6E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54D38F-ACAF-A205-40EC-851D29EE0B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10C9EE-E2FD-F978-6FAD-828A77DEA4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8BCC48-855E-AEB0-C623-0456537C1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F69E7A-4F67-39A8-27A0-CF69F12D1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3F9AB3-29AB-FD73-F3BC-D0DD2D25D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651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A3BD03-DBB2-C65B-2672-1ADB53AABC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C4B2DC-7296-A75C-A1EA-83780F55B9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756F74-7F91-EDE1-D2A8-59232F087D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E43D30B-0688-A10E-8B7A-20A568509C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D22F133-C96B-1B3D-738E-5F4085E507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6B570D0-8299-59B7-8AF6-6B8F786D4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B6D019-B45F-AE73-F024-B4818BE44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3F22F1C-A724-AF9A-FF19-2339F38B4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069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9462E-C5CE-44C6-B7EC-18C68C6083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68BB21-6790-B520-12AF-6B77FB84A2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EADC14-7A05-39B9-2246-DA20DFBAF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B6C28DF-DFF1-0069-2934-7C02940E4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886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25301E-2C11-C5B5-1731-DB1FD4C16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51A770-0888-A1F4-827E-AC37781D8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99774E-2F83-C878-E992-5B3F81AB2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650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C8350E-4DDF-7736-95C1-77ABCDB637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C648EF-37CB-236B-3F25-7D43EC9054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9F423B-F9D7-F6CC-B525-14EF966AE4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17C61C-07BB-9A9A-5D41-847CC8C96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1D5CA5-6F97-3459-CB6C-823A39347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7C7CFF-0F7B-ABB2-445C-F074FFF83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815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3D5FD0-5ECD-E3CC-DC13-48D01EF5EA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81FEC97-92C1-F20D-D087-EE8A6FDBFF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01009B-1945-0814-DC1E-83703E7D7E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AACE7B-DA1E-6487-BF77-9CD718603B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B8EF0E-DDC8-0D96-BAF0-178C5F0CCC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EC0A3D-EF3F-4154-8B34-F4123A462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641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54F263-DDBE-47E7-3FA2-A54C20F670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2744EA-4603-E1FF-16D7-FA1783BC24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D8210F-9757-99E4-DF1B-224193ECBF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E3F7C4D-1D72-4E68-AD68-1984CA2179DB}" type="datetimeFigureOut">
              <a:rPr lang="en-US" smtClean="0"/>
              <a:t>7/1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9DD961-B305-68B7-DAD6-9B3D49184F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5A5C4C-CD4B-85DE-6AF9-B7EEAFE3D4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1550D6-31F8-446D-8B7C-04249C7133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660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graph of numbers and a graph&#10;&#10;AI-generated content may be incorrect.">
            <a:extLst>
              <a:ext uri="{FF2B5EF4-FFF2-40B4-BE49-F238E27FC236}">
                <a16:creationId xmlns:a16="http://schemas.microsoft.com/office/drawing/2014/main" id="{BFBA4531-302C-20E9-1E6A-F8DA8E8F42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410"/>
          <a:stretch>
            <a:fillRect/>
          </a:stretch>
        </p:blipFill>
        <p:spPr>
          <a:xfrm>
            <a:off x="1989056" y="442299"/>
            <a:ext cx="7847118" cy="387864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EFA5027-5C96-28FF-1E59-BFCAFFFF0E9E}"/>
              </a:ext>
            </a:extLst>
          </p:cNvPr>
          <p:cNvSpPr txBox="1"/>
          <p:nvPr/>
        </p:nvSpPr>
        <p:spPr>
          <a:xfrm rot="16200000">
            <a:off x="232502" y="1537984"/>
            <a:ext cx="246184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>
                <a:solidFill>
                  <a:schemeClr val="accent3">
                    <a:lumMod val="75000"/>
                  </a:schemeClr>
                </a:solidFill>
              </a:rPr>
              <a:t>Number of shared SNPs with blood cell trait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574FF48-F319-ACEF-DD6B-820ABB211595}"/>
              </a:ext>
            </a:extLst>
          </p:cNvPr>
          <p:cNvSpPr txBox="1"/>
          <p:nvPr/>
        </p:nvSpPr>
        <p:spPr>
          <a:xfrm>
            <a:off x="1287379" y="4375477"/>
            <a:ext cx="9325421" cy="21365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500" b="1" dirty="0"/>
              <a:t>S2 Figure. Association of the hub genes with blood cell traits.</a:t>
            </a:r>
          </a:p>
          <a:p>
            <a:pPr algn="just">
              <a:lnSpc>
                <a:spcPct val="150000"/>
              </a:lnSpc>
            </a:pPr>
            <a:r>
              <a:rPr lang="en-US" sz="1500" dirty="0"/>
              <a:t>Hub genes were prioritized according to their degree of association with blood cell traits. For this purpose, </a:t>
            </a:r>
            <a:r>
              <a:rPr lang="en-US" sz="1500" dirty="0" err="1"/>
              <a:t>eQTLs</a:t>
            </a:r>
            <a:r>
              <a:rPr lang="en-US" sz="1500" dirty="0"/>
              <a:t> associated with each gene (P&lt;5e-8, r</a:t>
            </a:r>
            <a:r>
              <a:rPr lang="en-US" sz="1500" baseline="30000" dirty="0"/>
              <a:t>2</a:t>
            </a:r>
            <a:r>
              <a:rPr lang="en-US" sz="1500" dirty="0"/>
              <a:t>&lt;0.2) were selected and their association (P&lt;5e-8) with blood cell traits were counted. IKZF1, NFE2 and CREB5 had the highest number of </a:t>
            </a:r>
            <a:r>
              <a:rPr lang="en-US" sz="1500" dirty="0" err="1"/>
              <a:t>eQTLs</a:t>
            </a:r>
            <a:r>
              <a:rPr lang="en-US" sz="1500" dirty="0"/>
              <a:t> (N&gt;31) shared with blood cell traits.</a:t>
            </a:r>
          </a:p>
          <a:p>
            <a:pPr algn="just">
              <a:lnSpc>
                <a:spcPct val="150000"/>
              </a:lnSpc>
            </a:pPr>
            <a:r>
              <a:rPr lang="en-US" sz="1500" dirty="0" err="1"/>
              <a:t>eQTL</a:t>
            </a:r>
            <a:r>
              <a:rPr lang="en-US" sz="1500" dirty="0"/>
              <a:t> summary association statistics were obtained from the </a:t>
            </a:r>
            <a:r>
              <a:rPr lang="en-US" sz="1500" dirty="0" err="1"/>
              <a:t>eQTLGen</a:t>
            </a:r>
            <a:r>
              <a:rPr lang="en-US" sz="1500" dirty="0"/>
              <a:t> study (PMID: 34475573) and GWAS summary association statistics for </a:t>
            </a:r>
            <a:r>
              <a:rPr lang="en-US" sz="1500"/>
              <a:t>blood cell traits </a:t>
            </a:r>
            <a:r>
              <a:rPr lang="en-US" sz="1500" dirty="0"/>
              <a:t>were obtained from the UK Biobank.</a:t>
            </a:r>
          </a:p>
        </p:txBody>
      </p:sp>
    </p:spTree>
    <p:extLst>
      <p:ext uri="{BB962C8B-B14F-4D97-AF65-F5344CB8AC3E}">
        <p14:creationId xmlns:p14="http://schemas.microsoft.com/office/powerpoint/2010/main" val="21896014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122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University of Ottawa Heart Institut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jid Nikpay</dc:creator>
  <cp:lastModifiedBy>Majid Nikpay</cp:lastModifiedBy>
  <cp:revision>6</cp:revision>
  <dcterms:created xsi:type="dcterms:W3CDTF">2025-07-15T09:59:55Z</dcterms:created>
  <dcterms:modified xsi:type="dcterms:W3CDTF">2025-07-18T12:44:44Z</dcterms:modified>
</cp:coreProperties>
</file>